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357" autoAdjust="0"/>
  </p:normalViewPr>
  <p:slideViewPr>
    <p:cSldViewPr snapToGrid="0">
      <p:cViewPr>
        <p:scale>
          <a:sx n="112" d="100"/>
          <a:sy n="112" d="100"/>
        </p:scale>
        <p:origin x="-390" y="-4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A6DD0D4-88AD-4190-BE75-AF67F625FE1A}" type="datetimeFigureOut">
              <a:rPr lang="en-US" smtClean="0"/>
              <a:t>9/14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FC6B461-0FB8-4AB9-9683-C79A44C8B4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16345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C6B461-0FB8-4AB9-9683-C79A44C8B46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1206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631AEA-372D-4993-8BE4-039BAF87FC15}" type="datetimeFigureOut">
              <a:rPr lang="en-US" smtClean="0"/>
              <a:t>9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F8E9C-AC2D-461E-8A0E-C87EBCE9F3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65411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631AEA-372D-4993-8BE4-039BAF87FC15}" type="datetimeFigureOut">
              <a:rPr lang="en-US" smtClean="0"/>
              <a:t>9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F8E9C-AC2D-461E-8A0E-C87EBCE9F3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18642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631AEA-372D-4993-8BE4-039BAF87FC15}" type="datetimeFigureOut">
              <a:rPr lang="en-US" smtClean="0"/>
              <a:t>9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F8E9C-AC2D-461E-8A0E-C87EBCE9F3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55032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631AEA-372D-4993-8BE4-039BAF87FC15}" type="datetimeFigureOut">
              <a:rPr lang="en-US" smtClean="0"/>
              <a:t>9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F8E9C-AC2D-461E-8A0E-C87EBCE9F3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68357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631AEA-372D-4993-8BE4-039BAF87FC15}" type="datetimeFigureOut">
              <a:rPr lang="en-US" smtClean="0"/>
              <a:t>9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F8E9C-AC2D-461E-8A0E-C87EBCE9F3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78699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631AEA-372D-4993-8BE4-039BAF87FC15}" type="datetimeFigureOut">
              <a:rPr lang="en-US" smtClean="0"/>
              <a:t>9/1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F8E9C-AC2D-461E-8A0E-C87EBCE9F3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48254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631AEA-372D-4993-8BE4-039BAF87FC15}" type="datetimeFigureOut">
              <a:rPr lang="en-US" smtClean="0"/>
              <a:t>9/14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F8E9C-AC2D-461E-8A0E-C87EBCE9F3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42136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631AEA-372D-4993-8BE4-039BAF87FC15}" type="datetimeFigureOut">
              <a:rPr lang="en-US" smtClean="0"/>
              <a:t>9/14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F8E9C-AC2D-461E-8A0E-C87EBCE9F3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45542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631AEA-372D-4993-8BE4-039BAF87FC15}" type="datetimeFigureOut">
              <a:rPr lang="en-US" smtClean="0"/>
              <a:t>9/14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F8E9C-AC2D-461E-8A0E-C87EBCE9F3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10394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631AEA-372D-4993-8BE4-039BAF87FC15}" type="datetimeFigureOut">
              <a:rPr lang="en-US" smtClean="0"/>
              <a:t>9/1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F8E9C-AC2D-461E-8A0E-C87EBCE9F3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34531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631AEA-372D-4993-8BE4-039BAF87FC15}" type="datetimeFigureOut">
              <a:rPr lang="en-US" smtClean="0"/>
              <a:t>9/1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F8E9C-AC2D-461E-8A0E-C87EBCE9F3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81855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631AEA-372D-4993-8BE4-039BAF87FC15}" type="datetimeFigureOut">
              <a:rPr lang="en-US" smtClean="0"/>
              <a:t>9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0F8E9C-AC2D-461E-8A0E-C87EBCE9F3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15515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2220681" y="5359735"/>
            <a:ext cx="7823205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/>
              <a:t>Additional file 2: Figure S1</a:t>
            </a:r>
            <a:r>
              <a:rPr lang="en-US" sz="1400" b="1" dirty="0" smtClean="0"/>
              <a:t>: </a:t>
            </a:r>
            <a:r>
              <a:rPr lang="en-US" sz="1400" dirty="0"/>
              <a:t>Schematic diagram of the RiceMetaSys database. Datasets were downloaded from the NCBI GEO and then were analyzed using GEO2R based script for the identification of DEGs. A comprehensive web based interface was developed to provide useful search information related to DEGs like commonly expressed genes, variety, tissue, stage, physical position and genic microsatellites.</a:t>
            </a:r>
            <a:endParaRPr lang="en-US" sz="1400" b="1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27564" y="340991"/>
            <a:ext cx="7259782" cy="49013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020603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49</TotalTime>
  <Words>68</Words>
  <Application>Microsoft Office PowerPoint</Application>
  <PresentationFormat>Custom</PresentationFormat>
  <Paragraphs>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hom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iceMetaSys</dc:title>
  <dc:creator>Moon</dc:creator>
  <cp:lastModifiedBy>dell</cp:lastModifiedBy>
  <cp:revision>59</cp:revision>
  <dcterms:created xsi:type="dcterms:W3CDTF">2016-10-25T04:47:19Z</dcterms:created>
  <dcterms:modified xsi:type="dcterms:W3CDTF">2017-09-14T05:12:41Z</dcterms:modified>
</cp:coreProperties>
</file>